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2" autoAdjust="0"/>
    <p:restoredTop sz="94660"/>
  </p:normalViewPr>
  <p:slideViewPr>
    <p:cSldViewPr snapToGrid="0">
      <p:cViewPr varScale="1">
        <p:scale>
          <a:sx n="72" d="100"/>
          <a:sy n="72" d="100"/>
        </p:scale>
        <p:origin x="24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A065C-3866-48E2-9714-B18A2641ED6D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157F8-90CA-4F55-903B-374C171509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372112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A065C-3866-48E2-9714-B18A2641ED6D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157F8-90CA-4F55-903B-374C171509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876575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A065C-3866-48E2-9714-B18A2641ED6D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157F8-90CA-4F55-903B-374C171509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95376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A065C-3866-48E2-9714-B18A2641ED6D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157F8-90CA-4F55-903B-374C171509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83254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A065C-3866-48E2-9714-B18A2641ED6D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157F8-90CA-4F55-903B-374C171509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88458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A065C-3866-48E2-9714-B18A2641ED6D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157F8-90CA-4F55-903B-374C171509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514370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A065C-3866-48E2-9714-B18A2641ED6D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157F8-90CA-4F55-903B-374C171509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6311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A065C-3866-48E2-9714-B18A2641ED6D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157F8-90CA-4F55-903B-374C171509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81227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A065C-3866-48E2-9714-B18A2641ED6D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157F8-90CA-4F55-903B-374C171509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373984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A065C-3866-48E2-9714-B18A2641ED6D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157F8-90CA-4F55-903B-374C171509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69486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A065C-3866-48E2-9714-B18A2641ED6D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157F8-90CA-4F55-903B-374C171509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31537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8A065C-3866-48E2-9714-B18A2641ED6D}" type="datetimeFigureOut">
              <a:rPr lang="fr-FR" smtClean="0"/>
              <a:t>02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D157F8-90CA-4F55-903B-374C171509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8231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685" y="1922929"/>
            <a:ext cx="6026131" cy="3711387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696686" y="6429828"/>
            <a:ext cx="5528130" cy="26046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4</a:t>
            </a:r>
            <a:endParaRPr lang="fr-FR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ffect of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ternal deprivation (alone) on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ecal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robial abundance in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ong-Evans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ats. The figure shows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oxplots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the normalized abundances,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n a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og-scale, of several OTUs of interest across samples. The results are expressed as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median and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terquartile range. Normalized abundances are also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lotted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s points on top </a:t>
            </a:r>
            <a:r>
              <a:rPr lang="en-US" sz="120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</a:t>
            </a:r>
            <a:r>
              <a:rPr lang="en-US" sz="120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ach boxplot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with a small amount of horizontal jitter.</a:t>
            </a:r>
            <a:endParaRPr lang="fr-FR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fr-FR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619682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70</Words>
  <Application>Microsoft Office PowerPoint</Application>
  <PresentationFormat>Format A4 (210 x 297 mm)</PresentationFormat>
  <Paragraphs>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inr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Valerie Dauge</dc:creator>
  <cp:lastModifiedBy>Valerie Dauge</cp:lastModifiedBy>
  <cp:revision>15</cp:revision>
  <dcterms:created xsi:type="dcterms:W3CDTF">2019-03-21T09:46:27Z</dcterms:created>
  <dcterms:modified xsi:type="dcterms:W3CDTF">2020-07-02T08:29:28Z</dcterms:modified>
</cp:coreProperties>
</file>